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5" r:id="rId2"/>
  </p:sldIdLst>
  <p:sldSz cx="9601200" cy="12801600" type="A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A671"/>
    <a:srgbClr val="009C00"/>
    <a:srgbClr val="F2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2" autoAdjust="0"/>
    <p:restoredTop sz="94660"/>
  </p:normalViewPr>
  <p:slideViewPr>
    <p:cSldViewPr snapToGrid="0">
      <p:cViewPr>
        <p:scale>
          <a:sx n="97" d="100"/>
          <a:sy n="97" d="100"/>
        </p:scale>
        <p:origin x="2000" y="-30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061E67-48FD-C94C-B503-BFBF8F8C4C9D}" type="datetimeFigureOut">
              <a:rPr lang="en-US" smtClean="0"/>
              <a:t>3/7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8D4E14-306F-E343-A403-3D059C3FD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19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36539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26236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66689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70007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8609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86915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63429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8162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5371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44665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3832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8CA22-1DDB-4930-BD3B-3BAF00CDF782}" type="datetimeFigureOut">
              <a:rPr lang="en-IN" smtClean="0"/>
              <a:t>07/03/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D6EAF-8E3A-43E5-B562-BF09E60DC82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8088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13" Type="http://schemas.openxmlformats.org/officeDocument/2006/relationships/image" Target="../media/image6.png"/><Relationship Id="rId18" Type="http://schemas.openxmlformats.org/officeDocument/2006/relationships/image" Target="../media/image11.png"/><Relationship Id="rId3" Type="http://schemas.microsoft.com/office/2007/relationships/media" Target="../media/media2.mp4"/><Relationship Id="rId21" Type="http://schemas.openxmlformats.org/officeDocument/2006/relationships/image" Target="../media/image14.png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5.png"/><Relationship Id="rId17" Type="http://schemas.openxmlformats.org/officeDocument/2006/relationships/image" Target="../media/image10.png"/><Relationship Id="rId2" Type="http://schemas.openxmlformats.org/officeDocument/2006/relationships/video" Target="../media/media1.mp4"/><Relationship Id="rId16" Type="http://schemas.openxmlformats.org/officeDocument/2006/relationships/image" Target="../media/image9.png"/><Relationship Id="rId20" Type="http://schemas.openxmlformats.org/officeDocument/2006/relationships/image" Target="../media/image13.png"/><Relationship Id="rId1" Type="http://schemas.microsoft.com/office/2007/relationships/media" Target="../media/media1.mp4"/><Relationship Id="rId6" Type="http://schemas.openxmlformats.org/officeDocument/2006/relationships/video" Target="../media/media3.avi"/><Relationship Id="rId11" Type="http://schemas.openxmlformats.org/officeDocument/2006/relationships/image" Target="../media/image4.png"/><Relationship Id="rId5" Type="http://schemas.microsoft.com/office/2007/relationships/media" Target="../media/media3.avi"/><Relationship Id="rId15" Type="http://schemas.openxmlformats.org/officeDocument/2006/relationships/image" Target="../media/image8.png"/><Relationship Id="rId10" Type="http://schemas.openxmlformats.org/officeDocument/2006/relationships/image" Target="../media/image3.png"/><Relationship Id="rId19" Type="http://schemas.openxmlformats.org/officeDocument/2006/relationships/image" Target="../media/image12.png"/><Relationship Id="rId4" Type="http://schemas.openxmlformats.org/officeDocument/2006/relationships/video" Target="../media/media2.mp4"/><Relationship Id="rId9" Type="http://schemas.openxmlformats.org/officeDocument/2006/relationships/image" Target="../media/image2.png"/><Relationship Id="rId14" Type="http://schemas.openxmlformats.org/officeDocument/2006/relationships/image" Target="../media/image7.png"/><Relationship Id="rId22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live w1118 casp DIC 21082019 1-5 WT 6-17 casp.lsm - live w1118 casp DIC 21082019 1-5 WT 6-17 casp #16-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2400146" y="1975291"/>
            <a:ext cx="4335524" cy="1728000"/>
          </a:xfrm>
          <a:prstGeom prst="rect">
            <a:avLst/>
          </a:prstGeom>
        </p:spPr>
      </p:pic>
      <p:pic>
        <p:nvPicPr>
          <p:cNvPr id="35" name="live w1118 casp DIC 21082019 1-5 WT 6-17 casp.lsm - live w1118 casp DIC 21082019 1-5 WT 6-17 casp #6-2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2400142" y="172637"/>
            <a:ext cx="4335524" cy="1728000"/>
          </a:xfrm>
          <a:prstGeom prst="rect">
            <a:avLst/>
          </a:prstGeom>
        </p:spPr>
      </p:pic>
      <p:pic>
        <p:nvPicPr>
          <p:cNvPr id="36" name="casp df 1-8 dl df 72 9-16 df 26 17-26.lsm - casp df 1-8 dl df 72 9-16 df 26 17-26 #3 - C=0-2 df_2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2399797" y="3760798"/>
            <a:ext cx="4300000" cy="1800000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 rot="16200000">
            <a:off x="1403920" y="4322975"/>
            <a:ext cx="1458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i="1" dirty="0" err="1"/>
              <a:t>Casp</a:t>
            </a:r>
            <a:r>
              <a:rPr lang="en-IN" sz="1400" b="1" i="1" baseline="30000" dirty="0" err="1"/>
              <a:t>lof</a:t>
            </a:r>
            <a:r>
              <a:rPr lang="en-IN" sz="1400" b="1" i="1" baseline="30000" dirty="0"/>
              <a:t> </a:t>
            </a:r>
            <a:r>
              <a:rPr lang="en-US" sz="1400" b="1" i="1" dirty="0"/>
              <a:t>/</a:t>
            </a:r>
            <a:r>
              <a:rPr lang="en-US" sz="1400" b="1" i="1" dirty="0" err="1"/>
              <a:t>Df</a:t>
            </a:r>
            <a:endParaRPr lang="en-IN" sz="1400" b="1" i="1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1437861" y="2615352"/>
            <a:ext cx="12968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i="1" dirty="0" err="1"/>
              <a:t>Casp</a:t>
            </a:r>
            <a:r>
              <a:rPr lang="en-IN" sz="1400" b="1" i="1" baseline="30000" dirty="0" err="1"/>
              <a:t>lof</a:t>
            </a:r>
            <a:r>
              <a:rPr lang="en-IN" sz="1400" b="1" i="1" baseline="30000" dirty="0"/>
              <a:t> </a:t>
            </a:r>
            <a:r>
              <a:rPr lang="en-IN" sz="1400" b="1" i="1" dirty="0"/>
              <a:t>/</a:t>
            </a:r>
            <a:r>
              <a:rPr lang="en-IN" sz="1400" b="1" i="1" dirty="0" err="1"/>
              <a:t>Casp</a:t>
            </a:r>
            <a:r>
              <a:rPr lang="en-IN" sz="1400" b="1" i="1" baseline="30000" dirty="0" err="1"/>
              <a:t>lof</a:t>
            </a:r>
            <a:endParaRPr lang="en-IN" sz="1400" b="1" i="1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1743711" y="936645"/>
            <a:ext cx="7728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i="1" dirty="0"/>
              <a:t>w</a:t>
            </a:r>
            <a:r>
              <a:rPr lang="en-IN" sz="1400" b="1" i="1" baseline="30000" dirty="0"/>
              <a:t>1118</a:t>
            </a:r>
            <a:endParaRPr lang="en-IN" sz="1400" b="1" i="1" dirty="0"/>
          </a:p>
        </p:txBody>
      </p:sp>
      <p:sp>
        <p:nvSpPr>
          <p:cNvPr id="40" name="TextBox 39"/>
          <p:cNvSpPr txBox="1"/>
          <p:nvPr/>
        </p:nvSpPr>
        <p:spPr>
          <a:xfrm>
            <a:off x="8626646" y="0"/>
            <a:ext cx="9583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000" b="1">
                <a:solidFill>
                  <a:schemeClr val="bg1">
                    <a:lumMod val="65000"/>
                  </a:schemeClr>
                </a:solidFill>
              </a:rPr>
              <a:t>Fig. S2</a:t>
            </a:r>
            <a:endParaRPr lang="en-IN" sz="2000" b="1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65878" y="230833"/>
            <a:ext cx="5384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2000" b="1" dirty="0"/>
              <a:t>A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05FFF87E-AFC0-AC5E-8712-2D671A87D56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65884" y="6083504"/>
            <a:ext cx="2300114" cy="933752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C54F37DA-ABF8-F02B-BA3E-FE8B708AA08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770378" y="8325487"/>
            <a:ext cx="2274414" cy="903768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81BED052-B562-93C7-8B7A-80B03D5CDC4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260449" y="7199200"/>
            <a:ext cx="2278697" cy="908052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C7DB4861-D73D-D610-E1BB-E07FCCF3808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73701" y="9442004"/>
            <a:ext cx="2295831" cy="912336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59202B08-3E72-BDF5-A98B-01DDB8B49C5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770378" y="6083504"/>
            <a:ext cx="2261565" cy="908053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96BE1FFB-EEB0-7B50-DF4C-A7B666940C6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163700" y="6068203"/>
            <a:ext cx="2171616" cy="908052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72F6D389-0833-49A0-DA38-53C8DF198BA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770378" y="7199200"/>
            <a:ext cx="2274414" cy="908052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71D66D15-4E1B-4B58-610B-371B5A688A4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770378" y="9437554"/>
            <a:ext cx="2270131" cy="908052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223C8421-F565-91F3-502B-4D939308E59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69434" y="8324885"/>
            <a:ext cx="2270131" cy="899486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3425AAEE-E5FC-9C80-C54A-F310E5B4FBE4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249171" y="7202585"/>
            <a:ext cx="2171616" cy="908052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148F65EB-5BBB-B294-4F2F-33891C1E53AC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256777" y="8328270"/>
            <a:ext cx="2150199" cy="899486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9CED19A5-D3C3-A389-716B-9900D6C83B2D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252493" y="9453956"/>
            <a:ext cx="2154483" cy="903769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A08A57E4-9DB7-E466-0EEF-1D9A2DB34662}"/>
              </a:ext>
            </a:extLst>
          </p:cNvPr>
          <p:cNvSpPr txBox="1"/>
          <p:nvPr/>
        </p:nvSpPr>
        <p:spPr>
          <a:xfrm rot="16200000">
            <a:off x="342619" y="7323953"/>
            <a:ext cx="101965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/>
              <a:t>Cephalic furrow formation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8A56B8E-0B46-6034-1307-2E8EFEA55296}"/>
              </a:ext>
            </a:extLst>
          </p:cNvPr>
          <p:cNvSpPr txBox="1"/>
          <p:nvPr/>
        </p:nvSpPr>
        <p:spPr>
          <a:xfrm rot="16200000">
            <a:off x="398644" y="8564142"/>
            <a:ext cx="11230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err="1"/>
              <a:t>Germband</a:t>
            </a:r>
            <a:r>
              <a:rPr lang="en-IN" sz="1400" b="1" dirty="0"/>
              <a:t> extension 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F9CF864-6E7C-D213-6C64-8051D1C0FF2C}"/>
              </a:ext>
            </a:extLst>
          </p:cNvPr>
          <p:cNvSpPr txBox="1"/>
          <p:nvPr/>
        </p:nvSpPr>
        <p:spPr>
          <a:xfrm rot="16200000">
            <a:off x="301059" y="9536507"/>
            <a:ext cx="11485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err="1"/>
              <a:t>Germband</a:t>
            </a:r>
            <a:r>
              <a:rPr lang="en-IN" sz="1400" b="1" dirty="0"/>
              <a:t> retraction begin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6D375CA-89FC-F835-DFF6-780C7A725AD4}"/>
              </a:ext>
            </a:extLst>
          </p:cNvPr>
          <p:cNvSpPr txBox="1"/>
          <p:nvPr/>
        </p:nvSpPr>
        <p:spPr>
          <a:xfrm rot="16200000">
            <a:off x="408169" y="6424264"/>
            <a:ext cx="1242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400" b="1" dirty="0" err="1"/>
              <a:t>Cellularization</a:t>
            </a:r>
            <a:endParaRPr lang="en-IN" sz="14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534A3E8-65CF-AE2F-C76A-B4300B772E85}"/>
              </a:ext>
            </a:extLst>
          </p:cNvPr>
          <p:cNvSpPr txBox="1"/>
          <p:nvPr/>
        </p:nvSpPr>
        <p:spPr>
          <a:xfrm>
            <a:off x="6843597" y="5754468"/>
            <a:ext cx="890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i="1" dirty="0" err="1"/>
              <a:t>Casp</a:t>
            </a:r>
            <a:r>
              <a:rPr lang="en-IN" sz="1200" b="1" i="1" baseline="30000" dirty="0" err="1"/>
              <a:t>lof</a:t>
            </a:r>
            <a:r>
              <a:rPr lang="en-IN" sz="1200" b="1" i="1" baseline="30000" dirty="0"/>
              <a:t> </a:t>
            </a:r>
            <a:r>
              <a:rPr lang="en-US" sz="1200" b="1" i="1" dirty="0"/>
              <a:t>/</a:t>
            </a:r>
            <a:r>
              <a:rPr lang="en-US" sz="1200" b="1" i="1" dirty="0" err="1"/>
              <a:t>Df</a:t>
            </a:r>
            <a:endParaRPr lang="en-IN" sz="1200" b="1" i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9D30400-CFE1-90B7-D7DF-9F5B066F13BB}"/>
              </a:ext>
            </a:extLst>
          </p:cNvPr>
          <p:cNvSpPr txBox="1"/>
          <p:nvPr/>
        </p:nvSpPr>
        <p:spPr>
          <a:xfrm>
            <a:off x="4350704" y="5760635"/>
            <a:ext cx="1113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i="1" dirty="0" err="1"/>
              <a:t>Casp</a:t>
            </a:r>
            <a:r>
              <a:rPr lang="en-IN" sz="1200" b="1" i="1" baseline="30000" dirty="0" err="1"/>
              <a:t>lof</a:t>
            </a:r>
            <a:r>
              <a:rPr lang="en-IN" sz="1200" b="1" i="1" baseline="30000" dirty="0"/>
              <a:t> </a:t>
            </a:r>
            <a:r>
              <a:rPr lang="en-IN" sz="1200" b="1" i="1" dirty="0"/>
              <a:t>/</a:t>
            </a:r>
            <a:r>
              <a:rPr lang="en-IN" sz="1200" b="1" i="1" dirty="0" err="1"/>
              <a:t>Casp</a:t>
            </a:r>
            <a:r>
              <a:rPr lang="en-IN" sz="1200" b="1" i="1" baseline="30000" dirty="0" err="1"/>
              <a:t>lof</a:t>
            </a:r>
            <a:endParaRPr lang="en-IN" sz="1200" b="1" i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462C35B-2A1B-5F6C-507B-082DFD641690}"/>
              </a:ext>
            </a:extLst>
          </p:cNvPr>
          <p:cNvSpPr txBox="1"/>
          <p:nvPr/>
        </p:nvSpPr>
        <p:spPr>
          <a:xfrm>
            <a:off x="1965958" y="5756768"/>
            <a:ext cx="7728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i="1" dirty="0"/>
              <a:t>w</a:t>
            </a:r>
            <a:r>
              <a:rPr lang="en-IN" sz="1200" b="1" i="1" baseline="30000" dirty="0"/>
              <a:t>1118</a:t>
            </a:r>
            <a:endParaRPr lang="en-IN" sz="1200" b="1" i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0463058-5882-2FD5-767F-50B8E50B8BA1}"/>
              </a:ext>
            </a:extLst>
          </p:cNvPr>
          <p:cNvSpPr txBox="1"/>
          <p:nvPr/>
        </p:nvSpPr>
        <p:spPr>
          <a:xfrm>
            <a:off x="1237515" y="6760255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B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72277F0-9D4D-A7BF-9F38-45731596BC8E}"/>
              </a:ext>
            </a:extLst>
          </p:cNvPr>
          <p:cNvSpPr txBox="1"/>
          <p:nvPr/>
        </p:nvSpPr>
        <p:spPr>
          <a:xfrm>
            <a:off x="1237515" y="7797479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B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6A2228E-5DED-2080-0F3B-3456BDE52304}"/>
              </a:ext>
            </a:extLst>
          </p:cNvPr>
          <p:cNvSpPr txBox="1"/>
          <p:nvPr/>
        </p:nvSpPr>
        <p:spPr>
          <a:xfrm>
            <a:off x="1253844" y="8962332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B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606EE7A-E23C-5A55-73BD-81E57D9A6B7B}"/>
              </a:ext>
            </a:extLst>
          </p:cNvPr>
          <p:cNvSpPr txBox="1"/>
          <p:nvPr/>
        </p:nvSpPr>
        <p:spPr>
          <a:xfrm>
            <a:off x="1264803" y="10065534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B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D57C0AB-96B8-CB31-9EBF-C716B83ECE10}"/>
              </a:ext>
            </a:extLst>
          </p:cNvPr>
          <p:cNvSpPr txBox="1"/>
          <p:nvPr/>
        </p:nvSpPr>
        <p:spPr>
          <a:xfrm>
            <a:off x="3731682" y="6701287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C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3CE8F4A-E1EF-D19A-55DC-4FC88956C914}"/>
              </a:ext>
            </a:extLst>
          </p:cNvPr>
          <p:cNvSpPr txBox="1"/>
          <p:nvPr/>
        </p:nvSpPr>
        <p:spPr>
          <a:xfrm>
            <a:off x="3740349" y="7766632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C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074AADE-9588-2AEF-13B5-FA6EFAA83550}"/>
              </a:ext>
            </a:extLst>
          </p:cNvPr>
          <p:cNvSpPr txBox="1"/>
          <p:nvPr/>
        </p:nvSpPr>
        <p:spPr>
          <a:xfrm>
            <a:off x="3731703" y="8898105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C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DD45B07-21E0-E03E-861E-AA8CA8CEF22F}"/>
              </a:ext>
            </a:extLst>
          </p:cNvPr>
          <p:cNvSpPr txBox="1"/>
          <p:nvPr/>
        </p:nvSpPr>
        <p:spPr>
          <a:xfrm>
            <a:off x="3752002" y="10024894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C4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CBD00C7-CE84-CD68-7E0F-7337ABF2EC21}"/>
              </a:ext>
            </a:extLst>
          </p:cNvPr>
          <p:cNvSpPr txBox="1"/>
          <p:nvPr/>
        </p:nvSpPr>
        <p:spPr>
          <a:xfrm>
            <a:off x="6192877" y="6741918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D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9F36AA7-12E3-6305-B60F-3A97DC19D789}"/>
              </a:ext>
            </a:extLst>
          </p:cNvPr>
          <p:cNvSpPr txBox="1"/>
          <p:nvPr/>
        </p:nvSpPr>
        <p:spPr>
          <a:xfrm>
            <a:off x="6196704" y="7807139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D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E48BC63-7F61-F844-E0F0-660E18FE726F}"/>
              </a:ext>
            </a:extLst>
          </p:cNvPr>
          <p:cNvSpPr txBox="1"/>
          <p:nvPr/>
        </p:nvSpPr>
        <p:spPr>
          <a:xfrm>
            <a:off x="6188549" y="8926220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D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4B5E603-AE0A-6902-39A9-64900977FDFB}"/>
              </a:ext>
            </a:extLst>
          </p:cNvPr>
          <p:cNvSpPr txBox="1"/>
          <p:nvPr/>
        </p:nvSpPr>
        <p:spPr>
          <a:xfrm>
            <a:off x="6191804" y="10075694"/>
            <a:ext cx="4682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400" b="1" dirty="0"/>
              <a:t>D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465A185-2820-2A6B-C084-80505A532555}"/>
              </a:ext>
            </a:extLst>
          </p:cNvPr>
          <p:cNvSpPr txBox="1"/>
          <p:nvPr/>
        </p:nvSpPr>
        <p:spPr>
          <a:xfrm>
            <a:off x="1" y="10710623"/>
            <a:ext cx="9584946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. S2.</a:t>
            </a:r>
            <a:r>
              <a:rPr lang="en-US" sz="1600" dirty="0"/>
              <a:t> </a:t>
            </a:r>
            <a:r>
              <a:rPr lang="en-US" sz="1600" b="1" i="1" dirty="0" err="1"/>
              <a:t>Casp</a:t>
            </a:r>
            <a:r>
              <a:rPr lang="en-US" sz="1600" b="1" dirty="0"/>
              <a:t> assists in progression to gastrulation. </a:t>
            </a:r>
          </a:p>
          <a:p>
            <a:r>
              <a:rPr lang="en-US" sz="1600" b="1" dirty="0"/>
              <a:t>(A) </a:t>
            </a:r>
            <a:r>
              <a:rPr lang="en-US" sz="1600" dirty="0"/>
              <a:t>Representative movies for the early development of the indicated genotypes are shown in D. </a:t>
            </a:r>
            <a:endParaRPr lang="en-US" sz="1600" b="1" dirty="0"/>
          </a:p>
          <a:p>
            <a:r>
              <a:rPr lang="en-US" sz="1600" b="1" dirty="0"/>
              <a:t>(B-D) </a:t>
            </a:r>
            <a:r>
              <a:rPr lang="en-US" sz="1600" dirty="0"/>
              <a:t>Time-lapse images are presented for the wild-type and mutants in B1-D4. Out of 96 time points imaged, four are shown for each genotype. Images were acquired from a single, constant plane unique to each embryo across 5-minute intervals. The developmental trajectory for </a:t>
            </a:r>
            <a:r>
              <a:rPr lang="en-US" sz="1600" i="1" dirty="0" err="1"/>
              <a:t>w</a:t>
            </a:r>
            <a:r>
              <a:rPr lang="en-US" sz="1600" i="1" baseline="30000" dirty="0" err="1"/>
              <a:t>1118</a:t>
            </a:r>
            <a:r>
              <a:rPr lang="en-US" sz="1600" dirty="0"/>
              <a:t> can be followed from the </a:t>
            </a:r>
            <a:r>
              <a:rPr lang="en-US" sz="1600" dirty="0" err="1"/>
              <a:t>cellularization</a:t>
            </a:r>
            <a:r>
              <a:rPr lang="en-US" sz="1600" dirty="0"/>
              <a:t> stage to the beginning of germ band retraction, for the time points indicated. Crucial developmental milestones are highlighted (B1-B4). </a:t>
            </a:r>
            <a:r>
              <a:rPr lang="en-US" sz="1600" i="1" dirty="0" err="1"/>
              <a:t>casp</a:t>
            </a:r>
            <a:r>
              <a:rPr lang="en-US" sz="1600" dirty="0"/>
              <a:t> mutants did not exhibit characteristic stages of morphogenesis at comparable time points (C1-C4, D1-D4), n = 10. </a:t>
            </a:r>
          </a:p>
        </p:txBody>
      </p:sp>
    </p:spTree>
    <p:extLst>
      <p:ext uri="{BB962C8B-B14F-4D97-AF65-F5344CB8AC3E}">
        <p14:creationId xmlns:p14="http://schemas.microsoft.com/office/powerpoint/2010/main" val="3538697844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34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35"/>
                </p:tgtEl>
              </p:cMediaNode>
            </p:video>
            <p:video>
              <p:cMediaNode vol="80000">
                <p:cTn id="4" fill="hold" display="0">
                  <p:stCondLst>
                    <p:cond delay="indefinite"/>
                  </p:stCondLst>
                </p:cTn>
                <p:tgtEl>
                  <p:spTgt spid="3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162</TotalTime>
  <Words>170</Words>
  <Application>Microsoft Macintosh PowerPoint</Application>
  <PresentationFormat>A3 Paper (297x420 mm)</PresentationFormat>
  <Paragraphs>27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Girish Ratnaparkhi</cp:lastModifiedBy>
  <cp:revision>241</cp:revision>
  <dcterms:created xsi:type="dcterms:W3CDTF">2022-04-25T04:39:30Z</dcterms:created>
  <dcterms:modified xsi:type="dcterms:W3CDTF">2024-03-07T02:13:22Z</dcterms:modified>
</cp:coreProperties>
</file>